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6"/>
  </p:handoutMasterIdLst>
  <p:sldIdLst>
    <p:sldId id="265" r:id="rId2"/>
    <p:sldId id="262" r:id="rId3"/>
    <p:sldId id="264" r:id="rId4"/>
    <p:sldId id="266" r:id="rId5"/>
  </p:sldIdLst>
  <p:sldSz cx="6858000" cy="9906000" type="A4"/>
  <p:notesSz cx="6808788" cy="99409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66" userDrawn="1">
          <p15:clr>
            <a:srgbClr val="A4A3A4"/>
          </p15:clr>
        </p15:guide>
        <p15:guide id="2" pos="3249" userDrawn="1">
          <p15:clr>
            <a:srgbClr val="A4A3A4"/>
          </p15:clr>
        </p15:guide>
        <p15:guide id="3" orient="horz" pos="128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 Julius Ngwa" initials="CJN" lastIdx="14" clrIdx="0">
    <p:extLst>
      <p:ext uri="{19B8F6BF-5375-455C-9EA6-DF929625EA0E}">
        <p15:presenceInfo xmlns:p15="http://schemas.microsoft.com/office/powerpoint/2012/main" userId="S-1-5-21-737634768-2064794770-1962122892-3170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2386" y="-240"/>
      </p:cViewPr>
      <p:guideLst>
        <p:guide orient="horz" pos="2666"/>
        <p:guide pos="3249"/>
        <p:guide orient="horz" pos="12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gwa\Desktop\HMT%20Manuscript%20project%20results%20new\Real%20time%20Analysis%20AGC%20BIx%201h%20Experiment%201%20manuscrip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GC!$N$4</c:f>
              <c:strCache>
                <c:ptCount val="1"/>
                <c:pt idx="0">
                  <c:v>aGC untreated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GC!$O$6:$R$6</c:f>
                <c:numCache>
                  <c:formatCode>General</c:formatCode>
                  <c:ptCount val="4"/>
                  <c:pt idx="0">
                    <c:v>2.3256066020668977</c:v>
                  </c:pt>
                  <c:pt idx="1">
                    <c:v>0.5840917925934288</c:v>
                  </c:pt>
                  <c:pt idx="2">
                    <c:v>1.0060447616159143</c:v>
                  </c:pt>
                </c:numCache>
              </c:numRef>
            </c:plus>
            <c:minus>
              <c:numRef>
                <c:f>AGC!$O$6:$R$6</c:f>
                <c:numCache>
                  <c:formatCode>General</c:formatCode>
                  <c:ptCount val="4"/>
                  <c:pt idx="0">
                    <c:v>2.3256066020668977</c:v>
                  </c:pt>
                  <c:pt idx="1">
                    <c:v>0.5840917925934288</c:v>
                  </c:pt>
                  <c:pt idx="2">
                    <c:v>1.00604476161591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GC!$O$2:$R$3</c:f>
              <c:strCache>
                <c:ptCount val="3"/>
                <c:pt idx="0">
                  <c:v>PF3D7_1250400</c:v>
                </c:pt>
                <c:pt idx="1">
                  <c:v>PF3D7_1466500</c:v>
                </c:pt>
                <c:pt idx="2">
                  <c:v>PF3D7_0617800</c:v>
                </c:pt>
              </c:strCache>
            </c:strRef>
          </c:cat>
          <c:val>
            <c:numRef>
              <c:f>AGC!$O$4:$R$4</c:f>
              <c:numCache>
                <c:formatCode>0.0</c:formatCode>
                <c:ptCount val="4"/>
                <c:pt idx="0">
                  <c:v>33.461119665949106</c:v>
                </c:pt>
                <c:pt idx="1">
                  <c:v>11.748465130805618</c:v>
                </c:pt>
                <c:pt idx="2">
                  <c:v>34.8510080590085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2B-40F2-86CC-85AD19B57D91}"/>
            </c:ext>
          </c:extLst>
        </c:ser>
        <c:ser>
          <c:idx val="1"/>
          <c:order val="1"/>
          <c:tx>
            <c:strRef>
              <c:f>AGC!$N$5</c:f>
              <c:strCache>
                <c:ptCount val="1"/>
                <c:pt idx="0">
                  <c:v>aGC BIX-01294 -treated 1 h</c:v>
                </c:pt>
              </c:strCache>
            </c:strRef>
          </c:tx>
          <c:spPr>
            <a:solidFill>
              <a:srgbClr val="ED7D3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GC!$O$7:$R$7</c:f>
                <c:numCache>
                  <c:formatCode>General</c:formatCode>
                  <c:ptCount val="4"/>
                  <c:pt idx="0">
                    <c:v>2.9253568257476723</c:v>
                  </c:pt>
                  <c:pt idx="1">
                    <c:v>0.55156513272241703</c:v>
                  </c:pt>
                  <c:pt idx="2">
                    <c:v>1.3132851127521501</c:v>
                  </c:pt>
                </c:numCache>
              </c:numRef>
            </c:plus>
            <c:minus>
              <c:numRef>
                <c:f>AGC!$O$7:$R$7</c:f>
                <c:numCache>
                  <c:formatCode>General</c:formatCode>
                  <c:ptCount val="4"/>
                  <c:pt idx="0">
                    <c:v>2.9253568257476723</c:v>
                  </c:pt>
                  <c:pt idx="1">
                    <c:v>0.55156513272241703</c:v>
                  </c:pt>
                  <c:pt idx="2">
                    <c:v>1.31328511275215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GC!$O$2:$R$3</c:f>
              <c:strCache>
                <c:ptCount val="3"/>
                <c:pt idx="0">
                  <c:v>PF3D7_1250400</c:v>
                </c:pt>
                <c:pt idx="1">
                  <c:v>PF3D7_1466500</c:v>
                </c:pt>
                <c:pt idx="2">
                  <c:v>PF3D7_0617800</c:v>
                </c:pt>
              </c:strCache>
            </c:strRef>
          </c:cat>
          <c:val>
            <c:numRef>
              <c:f>AGC!$O$5:$R$5</c:f>
              <c:numCache>
                <c:formatCode>0.0</c:formatCode>
                <c:ptCount val="4"/>
                <c:pt idx="0">
                  <c:v>38.908778349069365</c:v>
                </c:pt>
                <c:pt idx="1">
                  <c:v>14.724452575413638</c:v>
                </c:pt>
                <c:pt idx="2">
                  <c:v>42.846365398838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2B-40F2-86CC-85AD19B57D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98299136"/>
        <c:axId val="1898295328"/>
      </c:barChart>
      <c:catAx>
        <c:axId val="189829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8295328"/>
        <c:crosses val="autoZero"/>
        <c:auto val="1"/>
        <c:lblAlgn val="ctr"/>
        <c:lblOffset val="100"/>
        <c:noMultiLvlLbl val="0"/>
      </c:catAx>
      <c:valAx>
        <c:axId val="1898295328"/>
        <c:scaling>
          <c:orientation val="minMax"/>
        </c:scaling>
        <c:delete val="0"/>
        <c:axPos val="l"/>
        <c:numFmt formatCode="0.0" sourceLinked="1"/>
        <c:majorTickMark val="none"/>
        <c:min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8299136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/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50212" cy="4978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7004" y="0"/>
            <a:ext cx="2950212" cy="4978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9E0917-9959-4022-A093-8EFDB80E7B42}" type="datetimeFigureOut">
              <a:rPr lang="en-GB" smtClean="0"/>
              <a:t>10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43054"/>
            <a:ext cx="2950212" cy="49787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7004" y="9443054"/>
            <a:ext cx="2950212" cy="49787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419EC7-C32F-49E8-A8BF-D4DD701B73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9443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5333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436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2930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9876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618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0016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6043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4124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0652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8748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8068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CD34A-C755-41BD-B2FC-BC85C675329A}" type="datetimeFigureOut">
              <a:rPr lang="de-DE" smtClean="0"/>
              <a:t>10.10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997E3-E40F-4318-AC2F-7B39397EF9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3416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1005416" y="1046897"/>
            <a:ext cx="4554107" cy="174970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31264" y="4096158"/>
            <a:ext cx="59125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: Verification of SET primers used for RT-PCR.. The primers used for RT-PCR were tested on </a:t>
            </a:r>
            <a:r>
              <a:rPr lang="en-GB" sz="1200" i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falciparum 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DNA. 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613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92422" y="182880"/>
            <a:ext cx="5977552" cy="7778496"/>
            <a:chOff x="489135" y="871516"/>
            <a:chExt cx="6444105" cy="8298400"/>
          </a:xfrm>
        </p:grpSpPr>
        <p:sp>
          <p:nvSpPr>
            <p:cNvPr id="13" name="TextBox 12"/>
            <p:cNvSpPr txBox="1"/>
            <p:nvPr/>
          </p:nvSpPr>
          <p:spPr>
            <a:xfrm>
              <a:off x="1623063" y="2933378"/>
              <a:ext cx="674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/>
                <a:t>(a)</a:t>
              </a:r>
              <a:endParaRPr lang="en-GB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952222" y="2966831"/>
              <a:ext cx="6456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/>
                <a:t>(b)</a:t>
              </a:r>
              <a:endParaRPr lang="en-GB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45366" y="5249858"/>
              <a:ext cx="1053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/>
                <a:t>(c)</a:t>
              </a:r>
              <a:endParaRPr lang="en-GB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947316" y="5237666"/>
              <a:ext cx="728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/>
                <a:t>(d)</a:t>
              </a:r>
              <a:endParaRPr lang="en-GB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568579" y="8800584"/>
              <a:ext cx="7307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/>
                <a:t>(e)</a:t>
              </a:r>
              <a:endParaRPr lang="en-GB" b="1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95752" y="3229918"/>
              <a:ext cx="2937488" cy="20520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9135" y="3170378"/>
              <a:ext cx="3007428" cy="20520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60119" y="871516"/>
              <a:ext cx="3091465" cy="20520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7853" y="949557"/>
              <a:ext cx="2919761" cy="20520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36747" y="5479272"/>
              <a:ext cx="2593694" cy="3363646"/>
            </a:xfrm>
            <a:prstGeom prst="rect">
              <a:avLst/>
            </a:prstGeom>
          </p:spPr>
        </p:pic>
      </p:grpSp>
      <p:sp>
        <p:nvSpPr>
          <p:cNvPr id="5" name="Rectangle 4"/>
          <p:cNvSpPr/>
          <p:nvPr/>
        </p:nvSpPr>
        <p:spPr>
          <a:xfrm>
            <a:off x="483108" y="7961375"/>
            <a:ext cx="608838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Effect of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X-01294 treatment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 gametocyte development.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-d). Stage development of gametocytes following BIX-01294 treatment. Stage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 gametocytes were treated with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X-01294 at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baseline="-25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and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baseline="-25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concentrations as well as chloroquine  at IC</a:t>
            </a:r>
            <a:r>
              <a:rPr lang="en-US" sz="1200" baseline="-25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centration (c) and 1% DMSO (d) as controls and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ametocyte stages (II-V) were counted in a total of 1,000 RBCs every second day during the 10-day experiment.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e) Morphology of BIX-01294-treated gametocytes. Stage IV and V gametocytes were subjected to Giemsa staining and the morphology was investigated by light microscop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(a-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representative of three independent experiments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063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0062" y="1125912"/>
            <a:ext cx="3113779" cy="3600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86036" y="5529263"/>
            <a:ext cx="523142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GB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labeling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trol of gametocytes using n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m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abbi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a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S). Fixed gametocyte samples (GC stages II-V) as well as of activated gametocytes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t 30 min post-activation wer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labell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NRS (green) and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ualized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use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s230 antisera (red); nuclei were highlighted by Hoechst stain (blue). Bar, 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m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1018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/>
          </p:cNvGrpSpPr>
          <p:nvPr/>
        </p:nvGrpSpPr>
        <p:grpSpPr bwMode="auto">
          <a:xfrm>
            <a:off x="722376" y="2908300"/>
            <a:ext cx="4962143" cy="3192971"/>
            <a:chOff x="134166" y="398716"/>
            <a:chExt cx="4964146" cy="3192972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3480542"/>
                </p:ext>
              </p:extLst>
            </p:nvPr>
          </p:nvGraphicFramePr>
          <p:xfrm>
            <a:off x="526312" y="848488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Rectangle 5"/>
            <p:cNvSpPr/>
            <p:nvPr/>
          </p:nvSpPr>
          <p:spPr>
            <a:xfrm rot="16200000">
              <a:off x="-1032584" y="1565466"/>
              <a:ext cx="2647951" cy="31445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de-DE" sz="1400" b="0" dirty="0">
                  <a:solidFill>
                    <a:prstClr val="black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Relative </a:t>
              </a:r>
              <a:r>
                <a:rPr lang="de-DE" sz="1400" b="0" dirty="0" err="1">
                  <a:solidFill>
                    <a:prstClr val="black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expression</a:t>
              </a:r>
              <a:r>
                <a:rPr lang="de-DE" sz="1400" b="0" dirty="0">
                  <a:solidFill>
                    <a:prstClr val="black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 2</a:t>
              </a:r>
              <a:r>
                <a:rPr lang="de-DE" sz="1400" b="0" baseline="30000" dirty="0">
                  <a:solidFill>
                    <a:prstClr val="black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-ΔCt</a:t>
              </a:r>
              <a:endParaRPr lang="en-GB" sz="1400" b="0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Rectangle 7"/>
          <p:cNvSpPr/>
          <p:nvPr/>
        </p:nvSpPr>
        <p:spPr>
          <a:xfrm>
            <a:off x="781108" y="6541199"/>
            <a:ext cx="5231424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idation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roarray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gnostic RT-PC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monstrating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esence of stage-specific transcript in the gametocyte samples. Complementary DNA fro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X-01294-treat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untreate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metocytes at 1 h post-activati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be used for 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l-time RT-PC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tested for purity using diagnostic RT-PCR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ge specificity was investigated by using the primers for the gametocyte-specific gene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ccp2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 for the asexual blood stage gene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ama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used for negative control. The pfccp2-specific primers were further used i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lacking reverse transcriptase (-RT Pfccp2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to demonstrate lack of gDNA. (b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l time RT-PC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demonstrate the transcription levels of select genes. Three genes transcriptionally up-regulated in BIX-01294 treated activated gametocytes were re-investigated for their transcript levels using real time RT-PCR. Transcript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were calculated by the 2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ΔC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hod; the threshold cycle number (Ct) was normalized with the Ct of the gene encoding for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ry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NA synthetase as reference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58526" y="2725164"/>
            <a:ext cx="625284" cy="346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(a)</a:t>
            </a:r>
            <a:endParaRPr lang="en-GB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748798" y="6199884"/>
            <a:ext cx="625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(b)</a:t>
            </a:r>
            <a:endParaRPr lang="en-GB" b="1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7969" y="397190"/>
            <a:ext cx="3450336" cy="2353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0067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3</Words>
  <Application>Microsoft Office PowerPoint</Application>
  <PresentationFormat>A4 Paper (210x297 mm)</PresentationFormat>
  <Paragraphs>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Institute for Biology II - RWTH-Aa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abriele Pradel</dc:creator>
  <cp:lastModifiedBy>MDPI</cp:lastModifiedBy>
  <cp:revision>213</cp:revision>
  <cp:lastPrinted>2019-04-29T10:55:27Z</cp:lastPrinted>
  <dcterms:created xsi:type="dcterms:W3CDTF">2017-01-26T12:47:58Z</dcterms:created>
  <dcterms:modified xsi:type="dcterms:W3CDTF">2019-10-10T00:52:35Z</dcterms:modified>
</cp:coreProperties>
</file>